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85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25" autoAdjust="0"/>
    <p:restoredTop sz="92395" autoAdjust="0"/>
  </p:normalViewPr>
  <p:slideViewPr>
    <p:cSldViewPr snapToGrid="0" showGuides="1">
      <p:cViewPr>
        <p:scale>
          <a:sx n="100" d="100"/>
          <a:sy n="100" d="100"/>
        </p:scale>
        <p:origin x="1284" y="-2328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063674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8267" y="7010799"/>
            <a:ext cx="575418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|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richness and Shannon diversity index of Atacama soil samples depending on elevation and species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-b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richness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hannon diversity index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etween species (Tukey’s test with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.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d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tabolic richness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hannon diversity index (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etween elevations (Tukey’s test with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. Analyses were performed on soil samples collected in 2021. Panels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d not include soils from open areas.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.imb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riplex imbricat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.sp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esmi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nosissim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.doe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ffmannseggi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elli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.fr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rav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igid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6"/>
            <a:ext cx="5760000" cy="6470547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4" name="Image 3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87F80881-7E26-7485-557C-90B76ADB764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658" y="558666"/>
            <a:ext cx="2844000" cy="2934174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94665007-5D30-FCB1-BB90-D764D0456AD2}"/>
              </a:ext>
            </a:extLst>
          </p:cNvPr>
          <p:cNvSpPr txBox="1"/>
          <p:nvPr/>
        </p:nvSpPr>
        <p:spPr>
          <a:xfrm>
            <a:off x="540741" y="51809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pic>
        <p:nvPicPr>
          <p:cNvPr id="10" name="Image 9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150E95BA-55CA-3B08-C0F3-CE6CE295CFA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3066" y="3529304"/>
            <a:ext cx="2844000" cy="2934174"/>
          </a:xfrm>
          <a:prstGeom prst="rect">
            <a:avLst/>
          </a:prstGeom>
        </p:spPr>
      </p:pic>
      <p:pic>
        <p:nvPicPr>
          <p:cNvPr id="15" name="Image 14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C25E7CC6-D85C-5D5E-BB75-F8C06ABE0FE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3066" y="558666"/>
            <a:ext cx="2844000" cy="2934174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1C866C25-3DE5-0B14-3244-CCB7928B3D68}"/>
              </a:ext>
            </a:extLst>
          </p:cNvPr>
          <p:cNvSpPr txBox="1"/>
          <p:nvPr/>
        </p:nvSpPr>
        <p:spPr>
          <a:xfrm>
            <a:off x="3381050" y="5180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pic>
        <p:nvPicPr>
          <p:cNvPr id="8" name="Image 7" descr="Une image contenant graphique&#10;&#10;Description générée automatiquement">
            <a:extLst>
              <a:ext uri="{FF2B5EF4-FFF2-40B4-BE49-F238E27FC236}">
                <a16:creationId xmlns:a16="http://schemas.microsoft.com/office/drawing/2014/main" id="{5EBAE3D2-9B13-27AE-2FE0-F6ABDBB69FB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658" y="3571727"/>
            <a:ext cx="2844000" cy="2807931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9EAB6DD0-04D0-2E4B-D71E-F57B7BA4D680}"/>
              </a:ext>
            </a:extLst>
          </p:cNvPr>
          <p:cNvSpPr txBox="1"/>
          <p:nvPr/>
        </p:nvSpPr>
        <p:spPr>
          <a:xfrm>
            <a:off x="540741" y="341783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E762397-A5ED-BB5F-3139-217856D7C645}"/>
              </a:ext>
            </a:extLst>
          </p:cNvPr>
          <p:cNvSpPr txBox="1"/>
          <p:nvPr/>
        </p:nvSpPr>
        <p:spPr>
          <a:xfrm>
            <a:off x="3381050" y="341783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6417247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123</Words>
  <Application>Microsoft Office PowerPoint</Application>
  <PresentationFormat>Format A4 (210 x 297 mm)</PresentationFormat>
  <Paragraphs>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3:58:48Z</dcterms:modified>
</cp:coreProperties>
</file>